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ojemaye\Documents\Postdoc-%20experimental\ARGs-%20DNA\Magnetite\Adsorption%20stud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ojemaye\Documents\Postdoc-%20experimental\ARGs-%20DNA\Magnetite\Adsorption%20stud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ZA" sz="1800" b="1" dirty="0"/>
              <a:t>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Effect of time'!$Q$19</c:f>
              <c:strCache>
                <c:ptCount val="1"/>
                <c:pt idx="0">
                  <c:v>18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42534995625546806"/>
                  <c:y val="1.4142242636337125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P$20:$P$3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  <c:pt idx="6">
                  <c:v>90</c:v>
                </c:pt>
                <c:pt idx="7">
                  <c:v>120</c:v>
                </c:pt>
                <c:pt idx="8">
                  <c:v>180</c:v>
                </c:pt>
                <c:pt idx="9">
                  <c:v>240</c:v>
                </c:pt>
                <c:pt idx="10">
                  <c:v>300</c:v>
                </c:pt>
                <c:pt idx="11">
                  <c:v>360</c:v>
                </c:pt>
              </c:numCache>
            </c:numRef>
          </c:xVal>
          <c:yVal>
            <c:numRef>
              <c:f>'Effect of time'!$Q$20:$Q$31</c:f>
              <c:numCache>
                <c:formatCode>General</c:formatCode>
                <c:ptCount val="12"/>
                <c:pt idx="0">
                  <c:v>0.31489361702127661</c:v>
                </c:pt>
                <c:pt idx="1">
                  <c:v>0.53571075572775617</c:v>
                </c:pt>
                <c:pt idx="2">
                  <c:v>0.69209554040693133</c:v>
                </c:pt>
                <c:pt idx="3">
                  <c:v>0.89576901334956749</c:v>
                </c:pt>
                <c:pt idx="4">
                  <c:v>1.1617175710562091</c:v>
                </c:pt>
                <c:pt idx="5">
                  <c:v>1.5152064378149126</c:v>
                </c:pt>
                <c:pt idx="6">
                  <c:v>2.0679909467951885</c:v>
                </c:pt>
                <c:pt idx="7">
                  <c:v>2.6922319259307899</c:v>
                </c:pt>
                <c:pt idx="8">
                  <c:v>3.9498736083472283</c:v>
                </c:pt>
                <c:pt idx="9">
                  <c:v>5.3497505572656845</c:v>
                </c:pt>
                <c:pt idx="10">
                  <c:v>6.597782907185243</c:v>
                </c:pt>
                <c:pt idx="11">
                  <c:v>7.97911638674087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214-42A0-9E2F-529A2B89E321}"/>
            </c:ext>
          </c:extLst>
        </c:ser>
        <c:ser>
          <c:idx val="1"/>
          <c:order val="1"/>
          <c:tx>
            <c:strRef>
              <c:f>'Effect of time'!$R$19</c:f>
              <c:strCache>
                <c:ptCount val="1"/>
                <c:pt idx="0">
                  <c:v>16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5761154855643046E-2"/>
                  <c:y val="0.1639953339165937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ffect of time'!$P$20:$P$3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  <c:pt idx="6">
                  <c:v>90</c:v>
                </c:pt>
                <c:pt idx="7">
                  <c:v>120</c:v>
                </c:pt>
                <c:pt idx="8">
                  <c:v>180</c:v>
                </c:pt>
                <c:pt idx="9">
                  <c:v>240</c:v>
                </c:pt>
                <c:pt idx="10">
                  <c:v>300</c:v>
                </c:pt>
                <c:pt idx="11">
                  <c:v>360</c:v>
                </c:pt>
              </c:numCache>
            </c:numRef>
          </c:xVal>
          <c:yVal>
            <c:numRef>
              <c:f>'Effect of time'!$R$20:$R$31</c:f>
              <c:numCache>
                <c:formatCode>General</c:formatCode>
                <c:ptCount val="12"/>
                <c:pt idx="0">
                  <c:v>0.33663037154018766</c:v>
                </c:pt>
                <c:pt idx="1">
                  <c:v>0.57048452463925237</c:v>
                </c:pt>
                <c:pt idx="2">
                  <c:v>0.75176994379972251</c:v>
                </c:pt>
                <c:pt idx="3">
                  <c:v>1.3387344843272748</c:v>
                </c:pt>
                <c:pt idx="4">
                  <c:v>1.5438800033148252</c:v>
                </c:pt>
                <c:pt idx="5">
                  <c:v>1.7230062356416145</c:v>
                </c:pt>
                <c:pt idx="6">
                  <c:v>2.2577786653020979</c:v>
                </c:pt>
                <c:pt idx="7">
                  <c:v>2.8677566665877947</c:v>
                </c:pt>
                <c:pt idx="8">
                  <c:v>4.2778369645386745</c:v>
                </c:pt>
                <c:pt idx="9">
                  <c:v>5.7482065503884847</c:v>
                </c:pt>
                <c:pt idx="10">
                  <c:v>7.2194789715647874</c:v>
                </c:pt>
                <c:pt idx="11">
                  <c:v>8.66440817164562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214-42A0-9E2F-529A2B89E321}"/>
            </c:ext>
          </c:extLst>
        </c:ser>
        <c:ser>
          <c:idx val="2"/>
          <c:order val="2"/>
          <c:tx>
            <c:strRef>
              <c:f>'Effect of time'!$S$19</c:f>
              <c:strCache>
                <c:ptCount val="1"/>
                <c:pt idx="0">
                  <c:v>14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P$20:$P$31</c:f>
              <c:numCache>
                <c:formatCode>General</c:formatCode>
                <c:ptCount val="12"/>
                <c:pt idx="0">
                  <c:v>5</c:v>
                </c:pt>
                <c:pt idx="1">
                  <c:v>10</c:v>
                </c:pt>
                <c:pt idx="2">
                  <c:v>15</c:v>
                </c:pt>
                <c:pt idx="3">
                  <c:v>30</c:v>
                </c:pt>
                <c:pt idx="4">
                  <c:v>45</c:v>
                </c:pt>
                <c:pt idx="5">
                  <c:v>60</c:v>
                </c:pt>
                <c:pt idx="6">
                  <c:v>90</c:v>
                </c:pt>
                <c:pt idx="7">
                  <c:v>120</c:v>
                </c:pt>
                <c:pt idx="8">
                  <c:v>180</c:v>
                </c:pt>
                <c:pt idx="9">
                  <c:v>240</c:v>
                </c:pt>
                <c:pt idx="10">
                  <c:v>300</c:v>
                </c:pt>
                <c:pt idx="11">
                  <c:v>360</c:v>
                </c:pt>
              </c:numCache>
            </c:numRef>
          </c:xVal>
          <c:yVal>
            <c:numRef>
              <c:f>'Effect of time'!$S$20:$S$31</c:f>
              <c:numCache>
                <c:formatCode>General</c:formatCode>
                <c:ptCount val="12"/>
                <c:pt idx="0">
                  <c:v>0.38856136589847662</c:v>
                </c:pt>
                <c:pt idx="1">
                  <c:v>0.63752001691996285</c:v>
                </c:pt>
                <c:pt idx="2">
                  <c:v>1.4740959832077098</c:v>
                </c:pt>
                <c:pt idx="3">
                  <c:v>2.3749135347014074</c:v>
                </c:pt>
                <c:pt idx="4">
                  <c:v>2.3175100761307661</c:v>
                </c:pt>
                <c:pt idx="5">
                  <c:v>2.3779417592994516</c:v>
                </c:pt>
                <c:pt idx="6">
                  <c:v>3.0159047714314298</c:v>
                </c:pt>
                <c:pt idx="7">
                  <c:v>3.7648520618156405</c:v>
                </c:pt>
                <c:pt idx="8">
                  <c:v>5.5977694711685775</c:v>
                </c:pt>
                <c:pt idx="9">
                  <c:v>7.4730710209919406</c:v>
                </c:pt>
                <c:pt idx="10">
                  <c:v>9.3592724490096249</c:v>
                </c:pt>
                <c:pt idx="11">
                  <c:v>11.2486672195237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214-42A0-9E2F-529A2B89E3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896176"/>
        <c:axId val="1934867920"/>
      </c:scatterChart>
      <c:valAx>
        <c:axId val="514896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4867920"/>
        <c:crosses val="autoZero"/>
        <c:crossBetween val="midCat"/>
      </c:valAx>
      <c:valAx>
        <c:axId val="19348679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148961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290222554892962"/>
          <c:y val="0.74479002624671919"/>
          <c:w val="0.88136914768474384"/>
          <c:h val="0.21817293671624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ZA" sz="1800" b="1" dirty="0"/>
              <a:t>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Effect of time'!$K$19</c:f>
              <c:strCache>
                <c:ptCount val="1"/>
                <c:pt idx="0">
                  <c:v>18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3.709317585301837E-2"/>
                  <c:y val="-0.1997674249052201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J$20:$J$32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  <c:pt idx="7">
                  <c:v>90</c:v>
                </c:pt>
                <c:pt idx="8">
                  <c:v>120</c:v>
                </c:pt>
                <c:pt idx="9">
                  <c:v>180</c:v>
                </c:pt>
                <c:pt idx="10">
                  <c:v>240</c:v>
                </c:pt>
                <c:pt idx="11">
                  <c:v>300</c:v>
                </c:pt>
                <c:pt idx="12">
                  <c:v>360</c:v>
                </c:pt>
              </c:numCache>
            </c:numRef>
          </c:xVal>
          <c:yVal>
            <c:numRef>
              <c:f>'Effect of time'!$K$20:$K$32</c:f>
              <c:numCache>
                <c:formatCode>General</c:formatCode>
                <c:ptCount val="13"/>
                <c:pt idx="0">
                  <c:v>3.82249515568436</c:v>
                </c:pt>
                <c:pt idx="1">
                  <c:v>3.3958417867520971</c:v>
                </c:pt>
                <c:pt idx="2">
                  <c:v>3.2977369239024812</c:v>
                </c:pt>
                <c:pt idx="3">
                  <c:v>3.1799200765484867</c:v>
                </c:pt>
                <c:pt idx="4">
                  <c:v>2.5036763337304349</c:v>
                </c:pt>
                <c:pt idx="5">
                  <c:v>1.9433914380111199</c:v>
                </c:pt>
                <c:pt idx="6">
                  <c:v>1.8114927161270391</c:v>
                </c:pt>
                <c:pt idx="7">
                  <c:v>0.78738405730783256</c:v>
                </c:pt>
                <c:pt idx="8">
                  <c:v>0.13580374789298033</c:v>
                </c:pt>
                <c:pt idx="9">
                  <c:v>-1.9169039456895733</c:v>
                </c:pt>
                <c:pt idx="10">
                  <c:v>-0.15521012973505174</c:v>
                </c:pt>
                <c:pt idx="11">
                  <c:v>-1.3930363163908173</c:v>
                </c:pt>
                <c:pt idx="12">
                  <c:v>-0.510222102218045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5DA-473C-AAD9-B995CD14569B}"/>
            </c:ext>
          </c:extLst>
        </c:ser>
        <c:ser>
          <c:idx val="1"/>
          <c:order val="1"/>
          <c:tx>
            <c:strRef>
              <c:f>'Effect of time'!$L$19</c:f>
              <c:strCache>
                <c:ptCount val="1"/>
                <c:pt idx="0">
                  <c:v>16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J$20:$J$32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  <c:pt idx="7">
                  <c:v>90</c:v>
                </c:pt>
                <c:pt idx="8">
                  <c:v>120</c:v>
                </c:pt>
                <c:pt idx="9">
                  <c:v>180</c:v>
                </c:pt>
                <c:pt idx="10">
                  <c:v>240</c:v>
                </c:pt>
                <c:pt idx="11">
                  <c:v>300</c:v>
                </c:pt>
                <c:pt idx="12">
                  <c:v>360</c:v>
                </c:pt>
              </c:numCache>
            </c:numRef>
          </c:xVal>
          <c:yVal>
            <c:numRef>
              <c:f>'Effect of time'!$L$20:$L$32</c:f>
              <c:numCache>
                <c:formatCode>General</c:formatCode>
                <c:ptCount val="13"/>
                <c:pt idx="0">
                  <c:v>3.7395093535036765</c:v>
                </c:pt>
                <c:pt idx="1">
                  <c:v>3.304108251739668</c:v>
                </c:pt>
                <c:pt idx="2">
                  <c:v>3.2006458937752429</c:v>
                </c:pt>
                <c:pt idx="3">
                  <c:v>3.0966823093676918</c:v>
                </c:pt>
                <c:pt idx="4">
                  <c:v>2.978998882978761</c:v>
                </c:pt>
                <c:pt idx="5">
                  <c:v>2.5595499611387984</c:v>
                </c:pt>
                <c:pt idx="6">
                  <c:v>1.9816196029055209</c:v>
                </c:pt>
                <c:pt idx="7">
                  <c:v>0.79532054802560415</c:v>
                </c:pt>
                <c:pt idx="8">
                  <c:v>-1.4576376588910478</c:v>
                </c:pt>
                <c:pt idx="9">
                  <c:v>-16.132984292266908</c:v>
                </c:pt>
                <c:pt idx="10">
                  <c:v>-1.1233552159213822</c:v>
                </c:pt>
                <c:pt idx="11">
                  <c:v>-0.64799272810002906</c:v>
                </c:pt>
                <c:pt idx="12">
                  <c:v>-0.638562597509545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5DA-473C-AAD9-B995CD14569B}"/>
            </c:ext>
          </c:extLst>
        </c:ser>
        <c:ser>
          <c:idx val="2"/>
          <c:order val="2"/>
          <c:tx>
            <c:strRef>
              <c:f>'Effect of time'!$M$19</c:f>
              <c:strCache>
                <c:ptCount val="1"/>
                <c:pt idx="0">
                  <c:v>14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9.3153980752405958E-3"/>
                  <c:y val="0.1682790172061825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J$20:$J$32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  <c:pt idx="7">
                  <c:v>90</c:v>
                </c:pt>
                <c:pt idx="8">
                  <c:v>120</c:v>
                </c:pt>
                <c:pt idx="9">
                  <c:v>180</c:v>
                </c:pt>
                <c:pt idx="10">
                  <c:v>240</c:v>
                </c:pt>
                <c:pt idx="11">
                  <c:v>300</c:v>
                </c:pt>
                <c:pt idx="12">
                  <c:v>360</c:v>
                </c:pt>
              </c:numCache>
            </c:numRef>
          </c:xVal>
          <c:yVal>
            <c:numRef>
              <c:f>'Effect of time'!$M$20:$M$32</c:f>
              <c:numCache>
                <c:formatCode>General</c:formatCode>
                <c:ptCount val="13"/>
                <c:pt idx="0">
                  <c:v>3.4705887959425983</c:v>
                </c:pt>
                <c:pt idx="1">
                  <c:v>2.9594670532563865</c:v>
                </c:pt>
                <c:pt idx="2">
                  <c:v>2.8015337444990771</c:v>
                </c:pt>
                <c:pt idx="3">
                  <c:v>3.0901303031421388</c:v>
                </c:pt>
                <c:pt idx="4">
                  <c:v>2.971625586484469</c:v>
                </c:pt>
                <c:pt idx="5">
                  <c:v>2.5446115307844246</c:v>
                </c:pt>
                <c:pt idx="6">
                  <c:v>1.9349597312069859</c:v>
                </c:pt>
                <c:pt idx="7">
                  <c:v>0.83892531764696576</c:v>
                </c:pt>
                <c:pt idx="8">
                  <c:v>-1.2661758370192482</c:v>
                </c:pt>
                <c:pt idx="9">
                  <c:v>-12.211010925995064</c:v>
                </c:pt>
                <c:pt idx="10">
                  <c:v>-3.209940979363763</c:v>
                </c:pt>
                <c:pt idx="11">
                  <c:v>-2.2837985199969948</c:v>
                </c:pt>
                <c:pt idx="12">
                  <c:v>-1.88467421705420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5DA-473C-AAD9-B995CD1456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4369680"/>
        <c:axId val="969709248"/>
      </c:scatterChart>
      <c:valAx>
        <c:axId val="1924369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9709248"/>
        <c:crosses val="autoZero"/>
        <c:crossBetween val="midCat"/>
      </c:valAx>
      <c:valAx>
        <c:axId val="9697092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436968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ZA" sz="1800" b="1" dirty="0"/>
              <a:t>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Effect of time'!$W$19</c:f>
              <c:strCache>
                <c:ptCount val="1"/>
                <c:pt idx="0">
                  <c:v>18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0873993875765529"/>
                  <c:y val="-4.0933945756780402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V$20:$V$31</c:f>
              <c:numCache>
                <c:formatCode>General</c:formatCode>
                <c:ptCount val="12"/>
                <c:pt idx="0">
                  <c:v>1.6094379124341003</c:v>
                </c:pt>
                <c:pt idx="1">
                  <c:v>2.3025850929940459</c:v>
                </c:pt>
                <c:pt idx="2">
                  <c:v>2.7080502011022101</c:v>
                </c:pt>
                <c:pt idx="3">
                  <c:v>3.4011973816621555</c:v>
                </c:pt>
                <c:pt idx="4">
                  <c:v>3.8066624897703196</c:v>
                </c:pt>
                <c:pt idx="5">
                  <c:v>4.0943445622221004</c:v>
                </c:pt>
                <c:pt idx="6">
                  <c:v>4.499809670330265</c:v>
                </c:pt>
                <c:pt idx="7">
                  <c:v>4.7874917427820458</c:v>
                </c:pt>
                <c:pt idx="8">
                  <c:v>5.1929568508902104</c:v>
                </c:pt>
                <c:pt idx="9">
                  <c:v>5.4806389233419912</c:v>
                </c:pt>
                <c:pt idx="10">
                  <c:v>5.7037824746562009</c:v>
                </c:pt>
                <c:pt idx="11">
                  <c:v>5.8861040314501558</c:v>
                </c:pt>
              </c:numCache>
            </c:numRef>
          </c:xVal>
          <c:yVal>
            <c:numRef>
              <c:f>'Effect of time'!$W$20:$W$31</c:f>
              <c:numCache>
                <c:formatCode>General</c:formatCode>
                <c:ptCount val="12"/>
                <c:pt idx="0">
                  <c:v>15.878378378378379</c:v>
                </c:pt>
                <c:pt idx="1">
                  <c:v>18.666789667896676</c:v>
                </c:pt>
                <c:pt idx="2">
                  <c:v>21.673308270676692</c:v>
                </c:pt>
                <c:pt idx="3">
                  <c:v>33.490776699029119</c:v>
                </c:pt>
                <c:pt idx="4">
                  <c:v>38.735748792270527</c:v>
                </c:pt>
                <c:pt idx="5">
                  <c:v>39.59856459330144</c:v>
                </c:pt>
                <c:pt idx="6">
                  <c:v>43.520499999999998</c:v>
                </c:pt>
                <c:pt idx="7">
                  <c:v>44.572682926829266</c:v>
                </c:pt>
                <c:pt idx="8">
                  <c:v>45.571078431372541</c:v>
                </c:pt>
                <c:pt idx="9">
                  <c:v>44.861904761904754</c:v>
                </c:pt>
                <c:pt idx="10">
                  <c:v>45.469819819819818</c:v>
                </c:pt>
                <c:pt idx="11">
                  <c:v>45.1177777777777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237-4AC5-80B5-8C3FDCB97A7E}"/>
            </c:ext>
          </c:extLst>
        </c:ser>
        <c:ser>
          <c:idx val="1"/>
          <c:order val="1"/>
          <c:tx>
            <c:strRef>
              <c:f>'Effect of time'!$X$19</c:f>
              <c:strCache>
                <c:ptCount val="1"/>
                <c:pt idx="0">
                  <c:v>16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2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9403783902012248"/>
                  <c:y val="0.1708796296296296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V$20:$V$31</c:f>
              <c:numCache>
                <c:formatCode>General</c:formatCode>
                <c:ptCount val="12"/>
                <c:pt idx="0">
                  <c:v>1.6094379124341003</c:v>
                </c:pt>
                <c:pt idx="1">
                  <c:v>2.3025850929940459</c:v>
                </c:pt>
                <c:pt idx="2">
                  <c:v>2.7080502011022101</c:v>
                </c:pt>
                <c:pt idx="3">
                  <c:v>3.4011973816621555</c:v>
                </c:pt>
                <c:pt idx="4">
                  <c:v>3.8066624897703196</c:v>
                </c:pt>
                <c:pt idx="5">
                  <c:v>4.0943445622221004</c:v>
                </c:pt>
                <c:pt idx="6">
                  <c:v>4.499809670330265</c:v>
                </c:pt>
                <c:pt idx="7">
                  <c:v>4.7874917427820458</c:v>
                </c:pt>
                <c:pt idx="8">
                  <c:v>5.1929568508902104</c:v>
                </c:pt>
                <c:pt idx="9">
                  <c:v>5.4806389233419912</c:v>
                </c:pt>
                <c:pt idx="10">
                  <c:v>5.7037824746562009</c:v>
                </c:pt>
                <c:pt idx="11">
                  <c:v>5.8861040314501558</c:v>
                </c:pt>
              </c:numCache>
            </c:numRef>
          </c:xVal>
          <c:yVal>
            <c:numRef>
              <c:f>'Effect of time'!$X$20:$X$31</c:f>
              <c:numCache>
                <c:formatCode>General</c:formatCode>
                <c:ptCount val="12"/>
                <c:pt idx="0">
                  <c:v>14.853086419753096</c:v>
                </c:pt>
                <c:pt idx="1">
                  <c:v>17.528959276018103</c:v>
                </c:pt>
                <c:pt idx="2">
                  <c:v>19.952912621359228</c:v>
                </c:pt>
                <c:pt idx="3">
                  <c:v>22.409223300970879</c:v>
                </c:pt>
                <c:pt idx="4">
                  <c:v>29.147342995169087</c:v>
                </c:pt>
                <c:pt idx="5">
                  <c:v>34.822857142857146</c:v>
                </c:pt>
                <c:pt idx="6">
                  <c:v>39.862189054726372</c:v>
                </c:pt>
                <c:pt idx="7">
                  <c:v>41.844554455445554</c:v>
                </c:pt>
                <c:pt idx="8">
                  <c:v>42.077339901477835</c:v>
                </c:pt>
                <c:pt idx="9">
                  <c:v>41.75215311004785</c:v>
                </c:pt>
                <c:pt idx="10">
                  <c:v>41.554245283018872</c:v>
                </c:pt>
                <c:pt idx="11">
                  <c:v>41.5492890995260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237-4AC5-80B5-8C3FDCB97A7E}"/>
            </c:ext>
          </c:extLst>
        </c:ser>
        <c:ser>
          <c:idx val="2"/>
          <c:order val="2"/>
          <c:tx>
            <c:strRef>
              <c:f>'Effect of time'!$Y$19</c:f>
              <c:strCache>
                <c:ptCount val="1"/>
                <c:pt idx="0">
                  <c:v>145 ng/mL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3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9324628171478564"/>
                  <c:y val="0.3171143190434528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ffect of time'!$V$20:$V$31</c:f>
              <c:numCache>
                <c:formatCode>General</c:formatCode>
                <c:ptCount val="12"/>
                <c:pt idx="0">
                  <c:v>1.6094379124341003</c:v>
                </c:pt>
                <c:pt idx="1">
                  <c:v>2.3025850929940459</c:v>
                </c:pt>
                <c:pt idx="2">
                  <c:v>2.7080502011022101</c:v>
                </c:pt>
                <c:pt idx="3">
                  <c:v>3.4011973816621555</c:v>
                </c:pt>
                <c:pt idx="4">
                  <c:v>3.8066624897703196</c:v>
                </c:pt>
                <c:pt idx="5">
                  <c:v>4.0943445622221004</c:v>
                </c:pt>
                <c:pt idx="6">
                  <c:v>4.499809670330265</c:v>
                </c:pt>
                <c:pt idx="7">
                  <c:v>4.7874917427820458</c:v>
                </c:pt>
                <c:pt idx="8">
                  <c:v>5.1929568508902104</c:v>
                </c:pt>
                <c:pt idx="9">
                  <c:v>5.4806389233419912</c:v>
                </c:pt>
                <c:pt idx="10">
                  <c:v>5.7037824746562009</c:v>
                </c:pt>
                <c:pt idx="11">
                  <c:v>5.8861040314501558</c:v>
                </c:pt>
              </c:numCache>
            </c:numRef>
          </c:xVal>
          <c:yVal>
            <c:numRef>
              <c:f>'Effect of time'!$Y$20:$Y$31</c:f>
              <c:numCache>
                <c:formatCode>General</c:formatCode>
                <c:ptCount val="12"/>
                <c:pt idx="0">
                  <c:v>12.867980295566495</c:v>
                </c:pt>
                <c:pt idx="1">
                  <c:v>15.685781990521319</c:v>
                </c:pt>
                <c:pt idx="2">
                  <c:v>10.175728155339801</c:v>
                </c:pt>
                <c:pt idx="3">
                  <c:v>12.632038834951452</c:v>
                </c:pt>
                <c:pt idx="4">
                  <c:v>19.417391304347824</c:v>
                </c:pt>
                <c:pt idx="5">
                  <c:v>25.231904761904755</c:v>
                </c:pt>
                <c:pt idx="6">
                  <c:v>29.841791044776116</c:v>
                </c:pt>
                <c:pt idx="7">
                  <c:v>31.873762376237622</c:v>
                </c:pt>
                <c:pt idx="8">
                  <c:v>32.155665024630537</c:v>
                </c:pt>
                <c:pt idx="9">
                  <c:v>32.115311004784687</c:v>
                </c:pt>
                <c:pt idx="10">
                  <c:v>32.053773584905656</c:v>
                </c:pt>
                <c:pt idx="11">
                  <c:v>32.0037914691943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237-4AC5-80B5-8C3FDCB97A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4370640"/>
        <c:axId val="1050817488"/>
      </c:scatterChart>
      <c:valAx>
        <c:axId val="1924370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0817488"/>
        <c:crosses val="autoZero"/>
        <c:crossBetween val="midCat"/>
      </c:valAx>
      <c:valAx>
        <c:axId val="10508174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43706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05D7C7-C8FB-6A74-B9FA-C01462BE29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45E7DF-4B76-0AD1-8D83-0907AE8CAA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4821A-244D-1CE5-12D3-CF7FEC667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C6A66-78A6-F296-8552-82AA4D0AE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54E102-0B46-C0DF-DDE9-3CF4902C9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97846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6CA4A-F538-B8B3-6890-F1DF61105F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D13DE6-EF26-BB9E-AF30-1F26BF0523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43EEFE-6E04-BCD2-E1F6-7461D26B6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DAAA3-CFCC-2F9F-426B-BED142F80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87AE1A-15AA-50C2-666B-7A74480AE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59944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0C8AAD-8F31-0CF0-F52F-A5CBB7AC62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0C66CB-798F-4B22-9B65-C581C82EC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F46C91-1831-94B5-77E1-B8BA21309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E6B23-1CC4-D320-F2CC-5D4F7E415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1C0501-2F3A-2D1E-02B9-43DD6A4F3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92703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59340-A968-88D9-051D-A67D28DB7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F2E76C-F45D-E74F-5E57-B597C466ED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ED8583-A538-7369-BED3-C9142E358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57B41-7F2D-F1CD-EA9E-9A6E2F145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3A5BA6-58F3-229B-9C2E-A3DEC4246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83665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9F103D-9EC1-33AF-9DE7-7617A123D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C9AFB9-4453-7F96-8209-E610630AA6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372EBF-7D29-BBA7-3F11-AB240D804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0F902-32DC-6E4E-153E-CA9915CC7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DF73A-9019-10FD-0B4E-4C733E383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75519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5B3D1F-7870-A919-56CD-A9D4A418A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CC69FC-5E63-CD66-B0C2-44116975BD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FE0FDC-744B-C6A5-C04F-35EE025D09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95B90-3FF5-69CB-7BC0-F663DF463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96769F-B04B-BF18-E8A5-6A58729B7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3D2404-9082-49F8-9BF1-0B9F088B2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1402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2D219-8AF3-1773-B7CF-F82B52C929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DB937C-7459-DACA-BDE7-7BC75FE11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C9FE1E-03ED-7261-DE6A-283DA93FEB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6955BD-D739-DA6A-2A59-7FFB8BF896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F8BCE9-CE71-FE25-1956-D7447E452C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1CAC04-5C13-8FD2-7247-3B3FA48FC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BF15FF-EC3A-DDAB-083F-B34164151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4ED4B2-BCEE-3ABF-3795-D20315771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2474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5025D-CE32-84A4-A136-D676B1400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678743-5101-008E-28E8-DB9C51FAB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4FC155-971B-330D-656C-D7CB2C0A8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42C4CA-98FC-26E9-0720-38BA1D18B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87013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A6A3A57-CDCE-AB6B-1A73-07D3F8B26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16E057-F297-89BC-F2A1-06F26A168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8CEF04-249D-75EF-EE47-973519E81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20511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3DA0A-6F18-91A5-66DE-D288FC9F43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1D812B-597C-286F-886D-2705017123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F268CA-B86F-F107-7364-D58DD64F23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EDA085-996B-B4F6-BE09-9EDAA5B6C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9CDFF4-A62F-9F5D-5E84-D637A88FF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9D1F34-E17E-ED02-201F-F0C4DF2DD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5962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6B84B-C5C6-2774-9AB1-9500D8E8E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4A16C5-8FD5-4AC4-1D0F-CBE5D439B2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BB8C66-83CD-F4E2-E123-91B8098C3A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327A4B-E6C6-544B-BC4D-2F8477D60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7EA023-8269-B84B-D67D-B5F1977C7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EAE7B9-3667-F67E-A90E-4E3FB700E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9846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2BBE9E-6CBB-6B20-D084-08E5CEAFA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A0E806-4D2F-C189-8716-2FE60318D2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D44E59-1726-F926-0D27-CF545146D0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0E7233-9305-4BB7-B7B6-2A496D03F0BF}" type="datetimeFigureOut">
              <a:rPr lang="en-ZA" smtClean="0"/>
              <a:t>2024/01/22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BB492B-FCA4-1CCE-D00C-5019A0D37E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78E6D-B5AA-8FDE-F172-EF47C16716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ADEEE0-FF31-447D-8A4F-D1A1ADEFE89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93131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5A127EEA-EE9D-7DF9-E2D9-1657EFB592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0665312"/>
              </p:ext>
            </p:extLst>
          </p:nvPr>
        </p:nvGraphicFramePr>
        <p:xfrm>
          <a:off x="1162334" y="1557240"/>
          <a:ext cx="9867332" cy="2021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66833">
                  <a:extLst>
                    <a:ext uri="{9D8B030D-6E8A-4147-A177-3AD203B41FA5}">
                      <a16:colId xmlns:a16="http://schemas.microsoft.com/office/drawing/2014/main" val="4046682932"/>
                    </a:ext>
                  </a:extLst>
                </a:gridCol>
                <a:gridCol w="3056338">
                  <a:extLst>
                    <a:ext uri="{9D8B030D-6E8A-4147-A177-3AD203B41FA5}">
                      <a16:colId xmlns:a16="http://schemas.microsoft.com/office/drawing/2014/main" val="3466967934"/>
                    </a:ext>
                  </a:extLst>
                </a:gridCol>
                <a:gridCol w="1877328">
                  <a:extLst>
                    <a:ext uri="{9D8B030D-6E8A-4147-A177-3AD203B41FA5}">
                      <a16:colId xmlns:a16="http://schemas.microsoft.com/office/drawing/2014/main" val="3020234990"/>
                    </a:ext>
                  </a:extLst>
                </a:gridCol>
                <a:gridCol w="2466833">
                  <a:extLst>
                    <a:ext uri="{9D8B030D-6E8A-4147-A177-3AD203B41FA5}">
                      <a16:colId xmlns:a16="http://schemas.microsoft.com/office/drawing/2014/main" val="385410202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8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inetics model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quation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rameters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ZA" dirty="0">
                          <a:solidFill>
                            <a:schemeClr val="tx1"/>
                          </a:solidFill>
                        </a:rPr>
                        <a:t>References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06252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ZA" dirty="0">
                          <a:solidFill>
                            <a:schemeClr val="tx1"/>
                          </a:solidFill>
                        </a:rPr>
                        <a:t>Pseudo 1</a:t>
                      </a:r>
                      <a:r>
                        <a:rPr lang="en-ZA" baseline="30000" dirty="0">
                          <a:solidFill>
                            <a:schemeClr val="tx1"/>
                          </a:solidFill>
                        </a:rPr>
                        <a:t>st</a:t>
                      </a:r>
                      <a:r>
                        <a:rPr lang="en-ZA" dirty="0">
                          <a:solidFill>
                            <a:schemeClr val="tx1"/>
                          </a:solidFill>
                        </a:rPr>
                        <a:t> Orde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i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</a:t>
                      </a:r>
                      <a:r>
                        <a:rPr lang="en-US" sz="1800" i="1" kern="1200" baseline="-250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</a:t>
                      </a:r>
                      <a:r>
                        <a:rPr lang="en-US" sz="1800" i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 </a:t>
                      </a:r>
                      <a:r>
                        <a:rPr lang="en-US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</a:t>
                      </a:r>
                      <a:r>
                        <a:rPr lang="en-US" sz="1800" i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Fuente-Cuesta et al., 2015)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2528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ZA" dirty="0">
                          <a:solidFill>
                            <a:schemeClr val="tx1"/>
                          </a:solidFill>
                        </a:rPr>
                        <a:t>Pseudo 2</a:t>
                      </a:r>
                      <a:r>
                        <a:rPr lang="en-ZA" baseline="30000" dirty="0">
                          <a:solidFill>
                            <a:schemeClr val="tx1"/>
                          </a:solidFill>
                        </a:rPr>
                        <a:t>nd</a:t>
                      </a:r>
                      <a:r>
                        <a:rPr lang="en-ZA" dirty="0">
                          <a:solidFill>
                            <a:schemeClr val="tx1"/>
                          </a:solidFill>
                        </a:rPr>
                        <a:t> Order</a:t>
                      </a:r>
                    </a:p>
                    <a:p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ZA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800" i="1" kern="12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</a:t>
                      </a:r>
                      <a:r>
                        <a:rPr lang="en-US" sz="1800" i="1" kern="1200" baseline="-2500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</a:t>
                      </a:r>
                      <a:r>
                        <a:rPr lang="en-US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k</a:t>
                      </a:r>
                      <a:r>
                        <a:rPr lang="en-US" sz="1800" i="1" kern="1200" baseline="-25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Fuente-Cuesta et al., 2015)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66079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ZA" dirty="0" err="1">
                          <a:solidFill>
                            <a:schemeClr val="tx1"/>
                          </a:solidFill>
                        </a:rPr>
                        <a:t>Elovich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i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α, β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Liu and Liu, 2008)</a:t>
                      </a:r>
                      <a:endParaRPr lang="en-ZA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336699"/>
                  </a:ext>
                </a:extLst>
              </a:tr>
            </a:tbl>
          </a:graphicData>
        </a:graphic>
      </p:graphicFrame>
      <p:pic>
        <p:nvPicPr>
          <p:cNvPr id="14" name="Picture 13">
            <a:extLst>
              <a:ext uri="{FF2B5EF4-FFF2-40B4-BE49-F238E27FC236}">
                <a16:creationId xmlns:a16="http://schemas.microsoft.com/office/drawing/2014/main" id="{1669A23E-5534-FB7E-AB3C-CDED2CDB15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4951" y="2581808"/>
            <a:ext cx="1115568" cy="40233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1B7B982-447B-4740-0202-8B38624BAB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6198" y="2022618"/>
            <a:ext cx="5691492" cy="44043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9EDD9DA-FFDA-5EFF-14F9-BF56263C98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5338" y="3292178"/>
            <a:ext cx="5942076" cy="46024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D23F400-1F73-E6E5-FECC-C56197267897}"/>
              </a:ext>
            </a:extLst>
          </p:cNvPr>
          <p:cNvSpPr txBox="1"/>
          <p:nvPr/>
        </p:nvSpPr>
        <p:spPr>
          <a:xfrm>
            <a:off x="1162334" y="1019366"/>
            <a:ext cx="666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Table 1: Kinetic equations and parameters employed in this study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209104D-F858-02E6-70B8-91C2884DCFDD}"/>
              </a:ext>
            </a:extLst>
          </p:cNvPr>
          <p:cNvSpPr txBox="1"/>
          <p:nvPr/>
        </p:nvSpPr>
        <p:spPr>
          <a:xfrm>
            <a:off x="3804951" y="531280"/>
            <a:ext cx="30811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Supplementary Informat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43E294-716E-ED79-048B-835BA8156E0C}"/>
              </a:ext>
            </a:extLst>
          </p:cNvPr>
          <p:cNvSpPr txBox="1"/>
          <p:nvPr/>
        </p:nvSpPr>
        <p:spPr>
          <a:xfrm>
            <a:off x="1162334" y="4060460"/>
            <a:ext cx="103444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</a:t>
            </a:r>
            <a:r>
              <a:rPr lang="en-US" sz="1800" i="1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mount of adsorbate adsorbed at time t (mg 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</a:t>
            </a:r>
            <a:r>
              <a:rPr lang="en-US" sz="18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mount of adsorbate adsorbed at equilibrium (mg 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dsorption rate constant (mg 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esorption rate constant (g m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r>
              <a:rPr lang="en-US" sz="1800" i="1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seudo-first order rate constant (mi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;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</a:t>
            </a:r>
            <a:r>
              <a:rPr lang="en-US" sz="1800" i="1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seudo-second order rate constant (g mg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n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604966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F0D98D58-38EB-031C-8B1B-5C194B4D5DBE}"/>
              </a:ext>
            </a:extLst>
          </p:cNvPr>
          <p:cNvGrpSpPr/>
          <p:nvPr/>
        </p:nvGrpSpPr>
        <p:grpSpPr>
          <a:xfrm>
            <a:off x="715617" y="415859"/>
            <a:ext cx="10588487" cy="5724937"/>
            <a:chOff x="715617" y="785191"/>
            <a:chExt cx="10588487" cy="5724937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C21F21EC-33EA-B92D-F386-D7232905FEC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72164765"/>
                </p:ext>
              </p:extLst>
            </p:nvPr>
          </p:nvGraphicFramePr>
          <p:xfrm>
            <a:off x="5638800" y="785191"/>
            <a:ext cx="5665304" cy="28624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B62FF14B-20FB-D8C9-2478-5ED7037941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56669967"/>
                </p:ext>
              </p:extLst>
            </p:nvPr>
          </p:nvGraphicFramePr>
          <p:xfrm>
            <a:off x="715617" y="785192"/>
            <a:ext cx="4923183" cy="28624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C5BC63B3-C620-D53D-94B2-89B2270DEC9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706388"/>
                </p:ext>
              </p:extLst>
            </p:nvPr>
          </p:nvGraphicFramePr>
          <p:xfrm>
            <a:off x="3177207" y="3647659"/>
            <a:ext cx="4923183" cy="28624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41F85123-B50D-3DE5-F645-AD23F2BE566C}"/>
              </a:ext>
            </a:extLst>
          </p:cNvPr>
          <p:cNvSpPr txBox="1"/>
          <p:nvPr/>
        </p:nvSpPr>
        <p:spPr>
          <a:xfrm>
            <a:off x="331304" y="6118974"/>
            <a:ext cx="115293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b="1" dirty="0"/>
              <a:t>Figure 1: Kinetic plot for the removal of DNA from aqueous solution (A) Pseudo 1</a:t>
            </a:r>
            <a:r>
              <a:rPr lang="en-ZA" b="1" baseline="30000" dirty="0"/>
              <a:t>st</a:t>
            </a:r>
            <a:r>
              <a:rPr lang="en-ZA" b="1" dirty="0"/>
              <a:t> order (B) Pseudo 2</a:t>
            </a:r>
            <a:r>
              <a:rPr lang="en-ZA" b="1" baseline="30000" dirty="0"/>
              <a:t>nd</a:t>
            </a:r>
            <a:r>
              <a:rPr lang="en-ZA" b="1" dirty="0"/>
              <a:t> order and (C) </a:t>
            </a:r>
            <a:r>
              <a:rPr lang="en-ZA" b="1" dirty="0" err="1"/>
              <a:t>Elovich</a:t>
            </a:r>
            <a:r>
              <a:rPr lang="en-ZA" b="1" dirty="0"/>
              <a:t> kinetic models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FDC0F1-B5C8-10E5-2313-1149E04DFA61}"/>
              </a:ext>
            </a:extLst>
          </p:cNvPr>
          <p:cNvSpPr txBox="1"/>
          <p:nvPr/>
        </p:nvSpPr>
        <p:spPr>
          <a:xfrm>
            <a:off x="4704521" y="98601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>
                <a:latin typeface="Arial" panose="020B0604020202020204" pitchFamily="34" charset="0"/>
                <a:cs typeface="Arial" panose="020B0604020202020204" pitchFamily="34" charset="0"/>
              </a:rPr>
              <a:t>Kinetic Plots</a:t>
            </a:r>
          </a:p>
        </p:txBody>
      </p:sp>
    </p:spTree>
    <p:extLst>
      <p:ext uri="{BB962C8B-B14F-4D97-AF65-F5344CB8AC3E}">
        <p14:creationId xmlns:p14="http://schemas.microsoft.com/office/powerpoint/2010/main" val="2649326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B47556F-E880-2C24-1955-9C395C84A4BB}"/>
              </a:ext>
            </a:extLst>
          </p:cNvPr>
          <p:cNvSpPr txBox="1"/>
          <p:nvPr/>
        </p:nvSpPr>
        <p:spPr>
          <a:xfrm>
            <a:off x="818866" y="614149"/>
            <a:ext cx="10650095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</a:p>
          <a:p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ente-Cuesta, A. .,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amantopoulou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. R. ., Lopez-Anton, M. A. ., Diaz-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moano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. . and Martínez-Tarazona, </a:t>
            </a:r>
          </a:p>
          <a:p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R.;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kellaropoulos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G. P. (2015) ‘Study of Mercury Adsorption by Low-Cost Sorbents Using Kinetic </a:t>
            </a:r>
          </a:p>
          <a:p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deling’, </a:t>
            </a:r>
            <a:r>
              <a:rPr lang="en-US" sz="16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ustrial &amp; Engineering Chemistry Research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54(21), pp. 5572–5579.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i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10.1021/acs.iecr.5b00262.</a:t>
            </a:r>
            <a:endParaRPr lang="en-ZA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u, Y. and Liu, Y. J. (2008) ‘Biosorption isotherms, kinetics and thermodynamics’, </a:t>
            </a:r>
            <a:r>
              <a:rPr lang="en-US" sz="16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paration and </a:t>
            </a:r>
          </a:p>
          <a:p>
            <a:r>
              <a:rPr lang="en-US" sz="16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urification Technology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61(3), pp. 229–242. </a:t>
            </a:r>
            <a:r>
              <a:rPr lang="en-US" sz="1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i</a:t>
            </a:r>
            <a:r>
              <a:rPr lang="en-US" sz="1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10.1016/j.seppur.2007.10.002.</a:t>
            </a:r>
            <a:endParaRPr lang="en-ZA" sz="1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849593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277</Words>
  <Application>Microsoft Office PowerPoint</Application>
  <PresentationFormat>Widescreen</PresentationFormat>
  <Paragraphs>3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Fort H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jemaye, Mike Onyewelehi</dc:creator>
  <cp:lastModifiedBy>Ojemaye, Mike Onyewelehi</cp:lastModifiedBy>
  <cp:revision>3</cp:revision>
  <dcterms:created xsi:type="dcterms:W3CDTF">2024-01-22T08:26:58Z</dcterms:created>
  <dcterms:modified xsi:type="dcterms:W3CDTF">2024-01-22T09:32:42Z</dcterms:modified>
</cp:coreProperties>
</file>